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2496" y="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660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433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520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855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260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507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842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00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369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756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294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DF195-577A-416A-B031-8A6330B6063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D09A7-9B95-4E25-BEBA-D59E42C078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965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5204203"/>
              </p:ext>
            </p:extLst>
          </p:nvPr>
        </p:nvGraphicFramePr>
        <p:xfrm>
          <a:off x="604202" y="2400420"/>
          <a:ext cx="5649595" cy="49377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991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299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502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0426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2743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5849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3975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4038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Q1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Q3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T (min)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ompound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Internal std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F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P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E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36.93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93.00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3.3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A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4-SA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63.0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53.2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.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B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6-AB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2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09.07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59.0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.6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J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6-J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22.19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30.1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.9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JA-Ile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6-JA-Ile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5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3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90.9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65.1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.6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OPD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6-J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38.1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30.1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OH-JA-Ile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6-JA-Ile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5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3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25.1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59.0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.6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OH-J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6-J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52.1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30.1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.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OOH-JA-Ile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6-JA-Ile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5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3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40.93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97.0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.3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4-S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69.0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59.2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.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6-AB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2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15.0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59.0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.6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6-J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14.0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59.0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.6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5-J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28.19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30.1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.9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6-JA-Ile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5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3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27.19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30.1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.9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5-JA-Ile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5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3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87.0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59.0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.3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plumbagin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6-JA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64.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20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18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588872" y="1703171"/>
            <a:ext cx="5540299" cy="923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1 Table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Details of phytohormones and plumbagin analyses by LC-MS/MS</a:t>
            </a:r>
            <a:r>
              <a:rPr kumimoji="0" lang="en-US" alt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[HPLC 1260 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(Agilent Technologies)-QTRAP6500 (SCIEX)] in negative ionization mode.</a:t>
            </a:r>
            <a:endParaRPr kumimoji="0" lang="en-US" altLang="en-US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717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1</Words>
  <Application>Microsoft Office PowerPoint</Application>
  <PresentationFormat>On-screen Show (4:3)</PresentationFormat>
  <Paragraphs>1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MPI for chemical ec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xel Mithoefer</dc:creator>
  <cp:lastModifiedBy>Axel Mithoefer</cp:lastModifiedBy>
  <cp:revision>10</cp:revision>
  <dcterms:created xsi:type="dcterms:W3CDTF">2021-03-30T11:30:46Z</dcterms:created>
  <dcterms:modified xsi:type="dcterms:W3CDTF">2021-09-23T12:48:29Z</dcterms:modified>
</cp:coreProperties>
</file>